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9" r:id="rId2"/>
    <p:sldId id="270" r:id="rId3"/>
    <p:sldId id="271" r:id="rId4"/>
    <p:sldId id="282" r:id="rId5"/>
    <p:sldId id="278" r:id="rId6"/>
    <p:sldId id="279" r:id="rId7"/>
    <p:sldId id="280" r:id="rId8"/>
    <p:sldId id="272" r:id="rId9"/>
    <p:sldId id="260" r:id="rId10"/>
    <p:sldId id="264" r:id="rId11"/>
    <p:sldId id="265" r:id="rId12"/>
    <p:sldId id="266" r:id="rId13"/>
    <p:sldId id="267" r:id="rId14"/>
    <p:sldId id="276" r:id="rId15"/>
    <p:sldId id="257" r:id="rId16"/>
    <p:sldId id="258" r:id="rId17"/>
    <p:sldId id="277" r:id="rId18"/>
    <p:sldId id="281" r:id="rId1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449" autoAdjust="0"/>
  </p:normalViewPr>
  <p:slideViewPr>
    <p:cSldViewPr snapToGrid="0">
      <p:cViewPr varScale="1">
        <p:scale>
          <a:sx n="54" d="100"/>
          <a:sy n="54" d="100"/>
        </p:scale>
        <p:origin x="11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3783E7-208F-4D9E-A0DF-7B4383B2BE11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E91DA3-2DD3-4B81-AE01-A0AB1829F8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18321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 Forest plot (A), leave-one-out analysis (B), scatter plot (C) and funnel plot (D) of the causal effect of IBD on PBC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BD: inflammatory bowel disease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4641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0. The shared risk genes which presented significant (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) differences in genes expression occurred in CD, PBC patients and normal subjects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: Crohn’s disease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438546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1.The shared risk genes which presented significant (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) differences in genes expression occurred in UC, PBC patients and normal subjects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C: ulcerative colitis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652172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2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trasting polygenicity between IBDs and periodontitis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BDs include IBD: inflammatory bowel disease, CD: Crohn’s disease, UC: ulcerative colitis and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54364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3. The shared risk genes which presented significant (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) differences in genes expression occurred in IBD, CD, UC, PBC patients and normal subjects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BD: inflammatory bowel disease, CD: Crohn’s disease, UC: ulcerative colitis, PBC: primary biliary cirrhos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09A829-B0BE-49AB-A526-9F4072C92BA5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735292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4. SNP heritability enrichment in 53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TEx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issues for PBC and IBD, including CD and UC. The x axis represents negative log10 FDR-adjusted 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values for each test, with the grey dotted lines indicating a 5% FDR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BD: inflammatory bowel disease, CD: Crohn’s disease, UC: ulcerative colitis, PBC: primary biliary cirrhosis, FDR: false discovery rate, SNP: single nucleotide polymorphism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FC3A8-99FA-4197-8C1D-9848293FC4FF}" type="slidenum">
              <a:rPr lang="zh-CN" altLang="en-US" smtClean="0"/>
              <a:t>1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139424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5. Heritability enrichment estimates in 28 lung cell types for primary biliary cirrhosis (PBC), inflammatory bowel disease (IBD), and Crohn’s disease (CD), using Multi-marker Analysis of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Mic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MAGMA)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x axis represents negative log10 FDR-adjusted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values for each test, with the grey dotted lines indicating a 5% FDR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FC3A8-99FA-4197-8C1D-9848293FC4FF}" type="slidenum">
              <a:rPr lang="zh-CN" altLang="en-US" smtClean="0"/>
              <a:t>1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0702788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6. Heritability enrichment estimates in 30 spleen cell types for primary biliary cirrhosis (PBC), inflammatory bowel disease (IBD), and Crohn’s disease (CD), using Multi-marker Analysis of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Mic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MAGMA)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x axis represents negative log10 FDR-adjusted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values for each test, with the grey dotted lines indicating a 5% FDR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FC3A8-99FA-4197-8C1D-9848293FC4FF}" type="slidenum">
              <a:rPr lang="zh-CN" altLang="en-US" smtClean="0"/>
              <a:t>1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2706067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7. Heritability enrichment estimates in 15 small-intestine terminal ileum cell types for, inflammatory bowel disease (IBD) and Crohn’s disease (CD), using Multi-marker Analysis of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Mic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MAGMA)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x axis represents negative log10 FDR-adjusted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values for each test, with the grey dotted lines indicating a 5% FDR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FC3A8-99FA-4197-8C1D-9848293FC4FF}" type="slidenum">
              <a:rPr lang="zh-CN" altLang="en-US" smtClean="0"/>
              <a:t>1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225608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8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ritability enrichment estimates in 8 (HSPC) cell types for inflammatory bowel disease (IBD), and Crohn’s disease (CD), using Multi-marker Analysis of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oMic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MAGMA). </a:t>
            </a:r>
            <a:r>
              <a:rPr lang="en-US" altLang="zh-CN" sz="1800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x axis represents negative log10 FDR-adjusted </a:t>
            </a:r>
            <a:r>
              <a:rPr lang="en-US" altLang="zh-CN" sz="1800" i="1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kern="1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values for each test, with the grey dotted lines indicating a 5% FDR.</a:t>
            </a:r>
            <a:endParaRPr lang="zh-CN" altLang="zh-CN" sz="1800" kern="10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FC3A8-99FA-4197-8C1D-9848293FC4FF}" type="slidenum">
              <a:rPr lang="zh-CN" altLang="en-US" smtClean="0"/>
              <a:t>1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82263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2. Forest plot (A), leave-one-out analysis (B), scatter plot (C) and funnel plot (D) of the causal effect of CD on PBC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D: Crohn’s disease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9714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3. Forest plot (A), leave-one-out analysis (B), scatter plot (C) and funnel plot (D) of the causal effect of UC on PBC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C: ulcerative colitis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5759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4. GSMR effect size plots for associations between PBC and each of IBD, CD and UC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BD: inflammatory bowel disease, CD: Crohn’s disease, UC: ulcerative colitis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919395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5. Forest plot (A), leave-one-out analysis (B), scatter plot (C) and funnel plot (D) of the causal effect of PBC on IBD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BD: inflammatory bowel disease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305156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6. Forest plot (A), leave-one-out analysis (B), scatter plot (C) and funnel plot (D) of the causal effect of PBC on CD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: Crohn’s disease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189704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7. Forest plot (A), leave-one-out analysis (B), scatter plot (C) and funnel plot (D) of the causal effect of PBC on UC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C: ulcerative colitis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31325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8. The estimation of causality between PBC and IBD (Including CD and UC) based on five Mendelian Randomization analysis methods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ve boxes represent GSMR, MR Egger, IVW, Weighted Median and Weighted Mode from the top to bottom. IBD: inflammatory bowel disease, CD: Crohn’s disease, UC: ulcerative colitis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903935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9. The shared risk genes which presented significant (</a:t>
            </a:r>
            <a:r>
              <a:rPr lang="en-US" altLang="zh-CN" sz="18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) differences in genes expression occurred in IBD, PBC patients and normal subjects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BD: inflammatory bowel disease, PBC: primary biliary cholangitis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E91DA3-2DD3-4B81-AE01-A0AB1829F807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7292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134068-25C2-287F-9E68-A8C6F6AE2D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31CA79-6EB6-7D99-1884-A01F401D47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DE21D7-69FF-FF5C-E3E5-2979A6941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696975-5813-AF4C-BAF1-4B6955BF1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203BBA-9A68-ECEB-4B19-C04193773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741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2C58A-17D9-44CE-2DB5-D433E463E4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EFB0B81-4A37-E3AD-DCB6-92ABCF0B78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EE19E5-40E7-FF77-5D2C-35DADA6D17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1C38B0-888C-E3F7-396D-4C15F3174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E9F5C0-6CBD-BE78-4644-FEB087F7B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9624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36EC8AE-678C-B539-E635-404CB7C146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AC961A6-A9E8-523E-5ED8-611DB06BCF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CBF06A-1DB5-51AC-F96E-95338D88F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CFA0DC-E3B8-9B02-9E2E-19DEE23A1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007FF5-C8D1-F0F8-81FC-A0BC05966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6269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B558BA-072F-6BA6-254F-9D887EFCB8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08B0276-2BF3-4812-BFA1-B0A5D6B71B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31DB4C-866D-3E11-B8B1-70A980C42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A0654E-59FD-90B2-B3AF-0CAA4C498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73BFE2-F959-327D-0CD9-D21EBC0EF0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353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1D4BAD-E2AD-6C9C-ECED-F9236FB117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D8DFA9-612D-E73F-343C-5A04F34F51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47DE8A-2FDA-BD1D-23A9-5235F5C44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306662-8D36-213B-1116-C2A540B9A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7047C2-44F2-8E72-163F-0B36FEF2B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7884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CED6DE-3C29-A118-A109-849259145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8F8B2BE-6822-0EC1-0C1A-756A8BA4CB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726962F-EE61-839C-E5B1-1D87AE5132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4104AA8-D83B-0AB1-66D4-22819F15D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1F7953-FF13-F0EE-6F2C-020ED1022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FC38BF-D270-011B-65B5-C14294A6B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24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022666-9F00-567D-9D58-E87E6282A2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B5158E8-E8A4-C1F7-7289-D2FD278355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071A437-12D7-17FA-C00C-804FEC4E30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63F47EA-1342-99DF-061C-34F92B1184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3D6A4DC-339F-B82A-C7CC-E682F7A370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0E947A4-1E9A-6592-4C23-F4CEA8BC6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05DDB17-E367-667C-F68C-14CE1E461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9F1748F-FD39-A606-C3F5-9A151CEF2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06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4C6992-3732-553D-4E04-D8AB764A4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E1A3816-7381-B12D-BF07-8611870EC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18F0959-1BA2-129A-3568-1E56C7AE5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11E7BBF-E34A-780C-AAF0-B08C94F2F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769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8549FF9-C44E-398A-014E-C3AF8145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54CA689-1F0B-DADF-2899-0FB6DA704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5078458-69B6-D351-DF0E-8C4F49C72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683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7B6ADE-4BF2-AB1B-0637-A485A60367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C1F8BA-C400-05CC-E27F-E7CF8C1DC9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3FEB873-D52B-3766-5028-DFA5652298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1BDBE5-C7DF-8EC0-001C-72538CDFE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3F5DC34-6230-517B-3826-4B0476B1D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4132F5-06EB-0232-B042-1B6D40EF1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546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378A28-68DA-DC50-C75B-C93A86F34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5BF9A90-462B-8611-5D06-80FFAB08E8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C0C741-4666-59F1-B4C2-2D53ED0499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A3D706-A4AB-66B1-D8F7-D1489C70C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712821-3ACE-966A-660A-A8FF9362A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D4EBEA-FEFC-1E9B-C4F5-16C58F0EC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8005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E47406B-0722-924A-1B8F-54DEF85E9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65A8FB-D3F0-E043-178E-5B76459EB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B28F0E-B149-54D1-DB19-F687C85961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8D3E7-5E81-4630-B3BE-7D81349B276D}" type="datetimeFigureOut">
              <a:rPr lang="zh-CN" altLang="en-US" smtClean="0"/>
              <a:t>2023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EE040C-9892-B976-9738-432FC14BEE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671155-351D-819E-F296-7641EAE704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53FA82-2A02-438B-99C4-5AF560ADB7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56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g"/><Relationship Id="rId3" Type="http://schemas.openxmlformats.org/officeDocument/2006/relationships/image" Target="../media/image38.jpg"/><Relationship Id="rId7" Type="http://schemas.openxmlformats.org/officeDocument/2006/relationships/image" Target="../media/image42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jpg"/><Relationship Id="rId5" Type="http://schemas.openxmlformats.org/officeDocument/2006/relationships/image" Target="../media/image40.jpg"/><Relationship Id="rId4" Type="http://schemas.openxmlformats.org/officeDocument/2006/relationships/image" Target="../media/image39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4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5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6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7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F153D575-1446-C32E-B491-D66201B0B9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9661" y="497394"/>
            <a:ext cx="4646779" cy="2821259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7AEA6127-10B4-F065-7CFB-7DFAA55FB1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476" y="3354382"/>
            <a:ext cx="4646779" cy="3293245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6EDE0272-2C6A-A89F-62A6-ECB70D514FD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7715" y="3318653"/>
            <a:ext cx="4646779" cy="329324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C9EAE6BD-5A0E-5FF6-065D-DA58CD31AB1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477" y="497394"/>
            <a:ext cx="4646779" cy="282125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A06B894-6E6E-F7C6-D9CD-A5D7C2B3EE63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23378A2-2BF1-DCB4-2D7A-D420BE9504A2}"/>
              </a:ext>
            </a:extLst>
          </p:cNvPr>
          <p:cNvSpPr txBox="1"/>
          <p:nvPr/>
        </p:nvSpPr>
        <p:spPr>
          <a:xfrm>
            <a:off x="300337" y="132835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2E17DD4-5256-0EDB-C331-B4AD77C35451}"/>
              </a:ext>
            </a:extLst>
          </p:cNvPr>
          <p:cNvSpPr txBox="1"/>
          <p:nvPr/>
        </p:nvSpPr>
        <p:spPr>
          <a:xfrm>
            <a:off x="300337" y="5160317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9B0E016-5C08-990B-9C8F-5CE4A050080B}"/>
              </a:ext>
            </a:extLst>
          </p:cNvPr>
          <p:cNvSpPr txBox="1"/>
          <p:nvPr/>
        </p:nvSpPr>
        <p:spPr>
          <a:xfrm>
            <a:off x="5770838" y="127343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D6987BA-3B80-2F8F-DA55-A578D2ABC470}"/>
              </a:ext>
            </a:extLst>
          </p:cNvPr>
          <p:cNvSpPr txBox="1"/>
          <p:nvPr/>
        </p:nvSpPr>
        <p:spPr>
          <a:xfrm>
            <a:off x="5770838" y="5160317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143139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A81A0EC-0D4B-AFAD-70B5-326CF9E20A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1359"/>
            <a:ext cx="12192000" cy="359528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AE12EFF-B95B-6C13-5549-51FAD93BD859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50078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DF6F43D-59F4-28B8-68E0-0447E7B3CD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1359"/>
            <a:ext cx="12192000" cy="359528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EBAAF880-C07B-54F2-0004-1DB6C757383B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1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73143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369D35AB-4E64-A13A-72FA-3E0E622164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8676" y="1189154"/>
            <a:ext cx="3774648" cy="292162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1717E0A-59DD-0B98-FBA5-7783A25F2A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95051"/>
            <a:ext cx="3774648" cy="292162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F123893-1694-D5B7-06BE-E06E713E838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5840" y="1207431"/>
            <a:ext cx="3774648" cy="292162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2AB9B894-5BB3-30DE-AF8D-683B9031A877}"/>
              </a:ext>
            </a:extLst>
          </p:cNvPr>
          <p:cNvSpPr txBox="1"/>
          <p:nvPr/>
        </p:nvSpPr>
        <p:spPr>
          <a:xfrm>
            <a:off x="1878980" y="4465391"/>
            <a:ext cx="1862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4BF7909-230B-B138-B6AC-6C94590A09A8}"/>
              </a:ext>
            </a:extLst>
          </p:cNvPr>
          <p:cNvSpPr txBox="1"/>
          <p:nvPr/>
        </p:nvSpPr>
        <p:spPr>
          <a:xfrm>
            <a:off x="10313020" y="4583148"/>
            <a:ext cx="1862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47FDE6A-AF2F-0900-6235-82B9B85E85A3}"/>
              </a:ext>
            </a:extLst>
          </p:cNvPr>
          <p:cNvSpPr txBox="1"/>
          <p:nvPr/>
        </p:nvSpPr>
        <p:spPr>
          <a:xfrm>
            <a:off x="6096000" y="4583148"/>
            <a:ext cx="1862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A56196D-BEEE-9080-D312-5622A4267216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2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968554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A7D7435-1A69-6DFC-883D-8E95ACB4A5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889" y="1056311"/>
            <a:ext cx="3047563" cy="216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5288102-4BD0-9A75-4FF0-BE1ABF99AC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865" y="3654982"/>
            <a:ext cx="3047564" cy="216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75687D2-B52A-CFE3-07EA-462607F5FDC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7402" y="1056311"/>
            <a:ext cx="3047564" cy="216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A74C634-E9A1-B2A7-0493-567CB67CBD2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3145" y="1056311"/>
            <a:ext cx="3047564" cy="216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B071BD4-55A8-A782-3543-A959EAD402C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3145" y="3654982"/>
            <a:ext cx="3047564" cy="2160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693A55B-BA4C-174A-1632-8A1ED066A86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7402" y="3654982"/>
            <a:ext cx="3047564" cy="2160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A5315F1-7CA4-ECA3-8FEB-2FA05163493C}"/>
              </a:ext>
            </a:extLst>
          </p:cNvPr>
          <p:cNvSpPr txBox="1"/>
          <p:nvPr/>
        </p:nvSpPr>
        <p:spPr>
          <a:xfrm>
            <a:off x="787400" y="10563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512BC378-0550-B5CD-1DE7-B762BDEC7431}"/>
              </a:ext>
            </a:extLst>
          </p:cNvPr>
          <p:cNvSpPr txBox="1"/>
          <p:nvPr/>
        </p:nvSpPr>
        <p:spPr>
          <a:xfrm>
            <a:off x="4193719" y="10563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20E83CF-36FF-C5F8-B507-488D73A2F42A}"/>
              </a:ext>
            </a:extLst>
          </p:cNvPr>
          <p:cNvSpPr txBox="1"/>
          <p:nvPr/>
        </p:nvSpPr>
        <p:spPr>
          <a:xfrm>
            <a:off x="7594166" y="10563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F859614-FE0B-270D-D9BF-A9B9297A794A}"/>
              </a:ext>
            </a:extLst>
          </p:cNvPr>
          <p:cNvSpPr txBox="1"/>
          <p:nvPr/>
        </p:nvSpPr>
        <p:spPr>
          <a:xfrm>
            <a:off x="787400" y="36549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89BD78E-581E-0AEB-0FD1-966DD5FFB7C2}"/>
              </a:ext>
            </a:extLst>
          </p:cNvPr>
          <p:cNvSpPr txBox="1"/>
          <p:nvPr/>
        </p:nvSpPr>
        <p:spPr>
          <a:xfrm>
            <a:off x="4193719" y="36549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8F72381-AFBC-FF43-D725-2706E9F93916}"/>
              </a:ext>
            </a:extLst>
          </p:cNvPr>
          <p:cNvSpPr txBox="1"/>
          <p:nvPr/>
        </p:nvSpPr>
        <p:spPr>
          <a:xfrm>
            <a:off x="7613925" y="365498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9F4ABE4-DD8E-191E-CBB9-322AD4278743}"/>
              </a:ext>
            </a:extLst>
          </p:cNvPr>
          <p:cNvSpPr txBox="1"/>
          <p:nvPr/>
        </p:nvSpPr>
        <p:spPr>
          <a:xfrm>
            <a:off x="0" y="0"/>
            <a:ext cx="3757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3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9154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4668D783-4037-6F0E-5ACB-78A2BD9E3E5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67093" y="372574"/>
          <a:ext cx="4057815" cy="61128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669977" imgH="7873871" progId="Prism8.Document">
                  <p:embed/>
                </p:oleObj>
              </mc:Choice>
              <mc:Fallback>
                <p:oleObj name="Prism 8" r:id="rId3" imgW="5669977" imgH="7873871" progId="Prism8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4668D783-4037-6F0E-5ACB-78A2BD9E3E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67093" y="372574"/>
                        <a:ext cx="4057815" cy="61128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974643BC-EB75-E357-12B7-58A9FC36423C}"/>
              </a:ext>
            </a:extLst>
          </p:cNvPr>
          <p:cNvSpPr txBox="1"/>
          <p:nvPr/>
        </p:nvSpPr>
        <p:spPr>
          <a:xfrm>
            <a:off x="0" y="0"/>
            <a:ext cx="3757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4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955512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C177F55F-3CDA-B599-3ED8-A42644F6BB8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18830" y="328613"/>
          <a:ext cx="4202723" cy="58787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6070808" imgH="7829945" progId="Prism8.Document">
                  <p:embed/>
                </p:oleObj>
              </mc:Choice>
              <mc:Fallback>
                <p:oleObj name="Prism 8" r:id="rId3" imgW="6070808" imgH="7829945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C177F55F-3CDA-B599-3ED8-A42644F6BB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18830" y="328613"/>
                        <a:ext cx="4202723" cy="58787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1EA6B308-7F77-D2D6-DE60-39FAD7A5410A}"/>
              </a:ext>
            </a:extLst>
          </p:cNvPr>
          <p:cNvSpPr txBox="1"/>
          <p:nvPr/>
        </p:nvSpPr>
        <p:spPr>
          <a:xfrm>
            <a:off x="0" y="0"/>
            <a:ext cx="3757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5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707374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BC349A5F-93D2-A8BF-B3E6-7F6F055EE27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59507" y="328613"/>
          <a:ext cx="3921369" cy="58787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5663854" imgH="7829945" progId="Prism8.Document">
                  <p:embed/>
                </p:oleObj>
              </mc:Choice>
              <mc:Fallback>
                <p:oleObj name="Prism 8" r:id="rId3" imgW="5663854" imgH="7829945" progId="Prism8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BC349A5F-93D2-A8BF-B3E6-7F6F055EE2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59507" y="328613"/>
                        <a:ext cx="3921369" cy="58787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1E14BE4C-B40A-1384-10B4-108D85FEE589}"/>
              </a:ext>
            </a:extLst>
          </p:cNvPr>
          <p:cNvSpPr txBox="1"/>
          <p:nvPr/>
        </p:nvSpPr>
        <p:spPr>
          <a:xfrm>
            <a:off x="0" y="0"/>
            <a:ext cx="3757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6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87971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03D28C85-FE01-5926-CA55-CFAE3CD9465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34192" y="489622"/>
          <a:ext cx="4466492" cy="58787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6451831" imgH="7829945" progId="Prism8.Document">
                  <p:embed/>
                </p:oleObj>
              </mc:Choice>
              <mc:Fallback>
                <p:oleObj name="Prism 8" r:id="rId3" imgW="6451831" imgH="7829945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03D28C85-FE01-5926-CA55-CFAE3CD946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34192" y="489622"/>
                        <a:ext cx="4466492" cy="58787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415A0054-52C8-1D12-CABC-D9D2B3093F28}"/>
              </a:ext>
            </a:extLst>
          </p:cNvPr>
          <p:cNvSpPr txBox="1"/>
          <p:nvPr/>
        </p:nvSpPr>
        <p:spPr>
          <a:xfrm>
            <a:off x="0" y="0"/>
            <a:ext cx="3757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7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316659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046D945F-C1A1-3B4F-9A23-81CD6FC7C79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10075" y="648433"/>
          <a:ext cx="3163033" cy="3955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569042" imgH="5267490" progId="Prism8.Document">
                  <p:embed/>
                </p:oleObj>
              </mc:Choice>
              <mc:Fallback>
                <p:oleObj name="Prism 8" r:id="rId3" imgW="4569042" imgH="5267490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046D945F-C1A1-3B4F-9A23-81CD6FC7C7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10075" y="648433"/>
                        <a:ext cx="3163033" cy="39554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1BD714C0-A460-45B6-83D6-B582353239BC}"/>
              </a:ext>
            </a:extLst>
          </p:cNvPr>
          <p:cNvSpPr txBox="1"/>
          <p:nvPr/>
        </p:nvSpPr>
        <p:spPr>
          <a:xfrm>
            <a:off x="0" y="0"/>
            <a:ext cx="3757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8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4785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25EED8F-2CDD-7CD2-7E16-58EA8E12DE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767" y="646771"/>
            <a:ext cx="4315521" cy="262013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D195406-5992-4C75-A2EF-40D43097AB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4126" y="646771"/>
            <a:ext cx="4315521" cy="262013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183D94DC-DD93-0496-44D7-ACC761E134E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4126" y="3536132"/>
            <a:ext cx="4315521" cy="3058477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F42F9D7-8084-2D02-3A3A-DFCEE90F7F9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767" y="3536132"/>
            <a:ext cx="4315521" cy="305847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C72E01A-A27A-0978-2DB3-0B772D2CB2F0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686259F-89C8-E9FB-F13C-94BB6E5C9D60}"/>
              </a:ext>
            </a:extLst>
          </p:cNvPr>
          <p:cNvSpPr txBox="1"/>
          <p:nvPr/>
        </p:nvSpPr>
        <p:spPr>
          <a:xfrm>
            <a:off x="266876" y="1406409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0BAEF28-E6B4-A346-E6BD-3E4406476037}"/>
              </a:ext>
            </a:extLst>
          </p:cNvPr>
          <p:cNvSpPr txBox="1"/>
          <p:nvPr/>
        </p:nvSpPr>
        <p:spPr>
          <a:xfrm>
            <a:off x="266876" y="5238374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C701936-75C1-63E7-8E9D-6F0ED619C66E}"/>
              </a:ext>
            </a:extLst>
          </p:cNvPr>
          <p:cNvSpPr txBox="1"/>
          <p:nvPr/>
        </p:nvSpPr>
        <p:spPr>
          <a:xfrm>
            <a:off x="5770838" y="127343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46E82B9-3C39-3451-E966-C81EB6F43038}"/>
              </a:ext>
            </a:extLst>
          </p:cNvPr>
          <p:cNvSpPr txBox="1"/>
          <p:nvPr/>
        </p:nvSpPr>
        <p:spPr>
          <a:xfrm>
            <a:off x="5770838" y="5212529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746747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BBD4FAF-3741-6F34-9DA3-ECFAB7FFF9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667" y="539739"/>
            <a:ext cx="4355300" cy="264428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9F233AA-E3EA-EAA4-92A4-1F5AA69E638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1918" y="539740"/>
            <a:ext cx="4474071" cy="27164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593E62F-D0A2-6FD2-960D-B634CD1CBD5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019" y="3735685"/>
            <a:ext cx="4112581" cy="291465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88A4831-7B59-84C6-3765-9077CF3DD7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458" y="3601861"/>
            <a:ext cx="4545314" cy="322133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B4D023B1-CD1E-6D38-6AFF-5039F195EE17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2274996-2108-CE79-7195-C3FC4FC8BC7B}"/>
              </a:ext>
            </a:extLst>
          </p:cNvPr>
          <p:cNvSpPr txBox="1"/>
          <p:nvPr/>
        </p:nvSpPr>
        <p:spPr>
          <a:xfrm>
            <a:off x="43856" y="132835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965CD87-4EB7-976C-B3DC-1AF6B73A9ABD}"/>
              </a:ext>
            </a:extLst>
          </p:cNvPr>
          <p:cNvSpPr txBox="1"/>
          <p:nvPr/>
        </p:nvSpPr>
        <p:spPr>
          <a:xfrm>
            <a:off x="43856" y="5160317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F7FC996-815B-3E3F-EA4F-2DA8F5FD83D6}"/>
              </a:ext>
            </a:extLst>
          </p:cNvPr>
          <p:cNvSpPr txBox="1"/>
          <p:nvPr/>
        </p:nvSpPr>
        <p:spPr>
          <a:xfrm>
            <a:off x="5770838" y="127343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4534859-79CF-9E06-5FF3-81F7F7A8A93F}"/>
              </a:ext>
            </a:extLst>
          </p:cNvPr>
          <p:cNvSpPr txBox="1"/>
          <p:nvPr/>
        </p:nvSpPr>
        <p:spPr>
          <a:xfrm>
            <a:off x="5770838" y="5212529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81307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FC46006-A7CF-E07A-32FA-1438489EAD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73" y="0"/>
            <a:ext cx="4152900" cy="29432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E1D79A5-F765-B909-6F4F-E98C08DE752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4949" y="30393"/>
            <a:ext cx="4294663" cy="304369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53887AA-E163-BE5E-FEE3-987A8F6A6D1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9613" y="230602"/>
            <a:ext cx="3729674" cy="2643279"/>
          </a:xfrm>
          <a:prstGeom prst="rect">
            <a:avLst/>
          </a:prstGeom>
        </p:spPr>
      </p:pic>
      <p:pic>
        <p:nvPicPr>
          <p:cNvPr id="12" name="内容占位符 4">
            <a:extLst>
              <a:ext uri="{FF2B5EF4-FFF2-40B4-BE49-F238E27FC236}">
                <a16:creationId xmlns:a16="http://schemas.microsoft.com/office/drawing/2014/main" id="{0E41FC6D-8834-8DA1-C510-ED0557B537B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713" y="3147121"/>
            <a:ext cx="4043421" cy="2865635"/>
          </a:xfr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CEE8FDA-7A5B-1231-610F-8201C8C96C6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6134" y="3043695"/>
            <a:ext cx="4459477" cy="316050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3785379-E07A-3B4A-C1C5-FF30ADA5618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62325" y="3560917"/>
            <a:ext cx="3729675" cy="2643279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8C1CE5F0-31D7-ED6A-80EF-A81C37DEDE4D}"/>
              </a:ext>
            </a:extLst>
          </p:cNvPr>
          <p:cNvSpPr txBox="1"/>
          <p:nvPr/>
        </p:nvSpPr>
        <p:spPr>
          <a:xfrm>
            <a:off x="1930400" y="2943225"/>
            <a:ext cx="168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45AA82A-86A8-F82A-685B-B8291A817A49}"/>
              </a:ext>
            </a:extLst>
          </p:cNvPr>
          <p:cNvSpPr txBox="1"/>
          <p:nvPr/>
        </p:nvSpPr>
        <p:spPr>
          <a:xfrm>
            <a:off x="6192281" y="2960977"/>
            <a:ext cx="168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800D067-5A0D-625A-264F-C1E21D2D653D}"/>
              </a:ext>
            </a:extLst>
          </p:cNvPr>
          <p:cNvSpPr txBox="1"/>
          <p:nvPr/>
        </p:nvSpPr>
        <p:spPr>
          <a:xfrm>
            <a:off x="10204450" y="2873881"/>
            <a:ext cx="168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6ADD929-53A2-3517-5670-4294B1F7766F}"/>
              </a:ext>
            </a:extLst>
          </p:cNvPr>
          <p:cNvSpPr txBox="1"/>
          <p:nvPr/>
        </p:nvSpPr>
        <p:spPr>
          <a:xfrm>
            <a:off x="1651000" y="6291405"/>
            <a:ext cx="168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F0251E3-C889-7297-7310-F94964E5A78A}"/>
              </a:ext>
            </a:extLst>
          </p:cNvPr>
          <p:cNvSpPr txBox="1"/>
          <p:nvPr/>
        </p:nvSpPr>
        <p:spPr>
          <a:xfrm>
            <a:off x="5912881" y="6309157"/>
            <a:ext cx="168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51EE398-9DE1-1F14-9253-FCBB3680D433}"/>
              </a:ext>
            </a:extLst>
          </p:cNvPr>
          <p:cNvSpPr txBox="1"/>
          <p:nvPr/>
        </p:nvSpPr>
        <p:spPr>
          <a:xfrm>
            <a:off x="9925050" y="6222061"/>
            <a:ext cx="168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522A815-F6F9-00AD-29BB-E957C6FF7CFF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00902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内容占位符 5">
            <a:extLst>
              <a:ext uri="{FF2B5EF4-FFF2-40B4-BE49-F238E27FC236}">
                <a16:creationId xmlns:a16="http://schemas.microsoft.com/office/drawing/2014/main" id="{E2FFB5C7-FA67-BE8E-0A0A-E6B93D3AEC2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039" y="593724"/>
            <a:ext cx="4241490" cy="2575191"/>
          </a:xfr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5EDC8F7-71D2-F5CF-F531-EC7606BD08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7857" y="593724"/>
            <a:ext cx="4439096" cy="269516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86E08CA-3FF1-48EA-3698-20B49C15F53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992" y="3197114"/>
            <a:ext cx="4833850" cy="342582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65A7A69-F6C7-A1FA-8FF4-06CC466CF4C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7550" y="3428999"/>
            <a:ext cx="4833850" cy="342582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E73BD364-18AF-ED6E-33D7-D5B983649AB2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B40D26E-BA40-ED5E-4F9E-E450F461A3B0}"/>
              </a:ext>
            </a:extLst>
          </p:cNvPr>
          <p:cNvSpPr txBox="1"/>
          <p:nvPr/>
        </p:nvSpPr>
        <p:spPr>
          <a:xfrm>
            <a:off x="43856" y="132835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393E127-0D77-3BE8-D6CC-BEC2200A58C1}"/>
              </a:ext>
            </a:extLst>
          </p:cNvPr>
          <p:cNvSpPr txBox="1"/>
          <p:nvPr/>
        </p:nvSpPr>
        <p:spPr>
          <a:xfrm>
            <a:off x="43856" y="5160317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C8DE794-9BF8-59FB-EBEA-F79EFBD7B4C2}"/>
              </a:ext>
            </a:extLst>
          </p:cNvPr>
          <p:cNvSpPr txBox="1"/>
          <p:nvPr/>
        </p:nvSpPr>
        <p:spPr>
          <a:xfrm>
            <a:off x="5770838" y="127343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43FC592-EF53-AE55-DF56-0FFC275BA758}"/>
              </a:ext>
            </a:extLst>
          </p:cNvPr>
          <p:cNvSpPr txBox="1"/>
          <p:nvPr/>
        </p:nvSpPr>
        <p:spPr>
          <a:xfrm>
            <a:off x="5770838" y="5212529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90701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内容占位符 5">
            <a:extLst>
              <a:ext uri="{FF2B5EF4-FFF2-40B4-BE49-F238E27FC236}">
                <a16:creationId xmlns:a16="http://schemas.microsoft.com/office/drawing/2014/main" id="{C8A1AAE9-4CD7-525F-F124-827C5E666F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302" y="736550"/>
            <a:ext cx="4081345" cy="2477960"/>
          </a:xfr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25C1E82-E5B8-9B40-1F64-F8AC663B2F8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458" y="690874"/>
            <a:ext cx="4231805" cy="256931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39B7CB8-B237-C1E9-A492-83DC17CB0A7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047" y="3614839"/>
            <a:ext cx="4429857" cy="313950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EFC259B-97F0-37F6-9F83-C0ED8FAFF38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7431" y="3718491"/>
            <a:ext cx="4429858" cy="313950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0C88C72-4533-B51A-C91F-445F05475173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0816542-8CF1-D596-AA41-9EBCFC90C00F}"/>
              </a:ext>
            </a:extLst>
          </p:cNvPr>
          <p:cNvSpPr txBox="1"/>
          <p:nvPr/>
        </p:nvSpPr>
        <p:spPr>
          <a:xfrm>
            <a:off x="5770838" y="127343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8B4A0E3-742C-4237-B927-9842A4CF038E}"/>
              </a:ext>
            </a:extLst>
          </p:cNvPr>
          <p:cNvSpPr txBox="1"/>
          <p:nvPr/>
        </p:nvSpPr>
        <p:spPr>
          <a:xfrm>
            <a:off x="5770838" y="5212529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152D76F-BF21-CD0F-4FFA-D5B24BEF6C0C}"/>
              </a:ext>
            </a:extLst>
          </p:cNvPr>
          <p:cNvSpPr txBox="1"/>
          <p:nvPr/>
        </p:nvSpPr>
        <p:spPr>
          <a:xfrm>
            <a:off x="330773" y="1352018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3EAC280-150A-C2FD-EF3F-7A33F1B2D7E4}"/>
              </a:ext>
            </a:extLst>
          </p:cNvPr>
          <p:cNvSpPr txBox="1"/>
          <p:nvPr/>
        </p:nvSpPr>
        <p:spPr>
          <a:xfrm>
            <a:off x="330773" y="5183984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974202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64529185-81DD-A3F0-0820-60D14A0833A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02" y="461665"/>
            <a:ext cx="4510110" cy="273828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0219B90-937D-C3B7-0E8D-99634DB5C0C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5636" y="461665"/>
            <a:ext cx="4510110" cy="273828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FFB2FEA-0625-412D-5BB7-E15BA1A5B56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666" y="3658054"/>
            <a:ext cx="4515134" cy="319994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53895FB-5BE5-D005-748D-A180087D9C6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5636" y="3658054"/>
            <a:ext cx="4515134" cy="3199946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302688E3-0A48-E43B-24CF-75E5A95B7E1D}"/>
              </a:ext>
            </a:extLst>
          </p:cNvPr>
          <p:cNvSpPr txBox="1"/>
          <p:nvPr/>
        </p:nvSpPr>
        <p:spPr>
          <a:xfrm>
            <a:off x="43856" y="132835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066982D-4D5E-911D-2312-835FD9241E8A}"/>
              </a:ext>
            </a:extLst>
          </p:cNvPr>
          <p:cNvSpPr txBox="1"/>
          <p:nvPr/>
        </p:nvSpPr>
        <p:spPr>
          <a:xfrm>
            <a:off x="43856" y="5160317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5B2BB27-9FBF-C644-980C-277E5D1B9DB5}"/>
              </a:ext>
            </a:extLst>
          </p:cNvPr>
          <p:cNvSpPr txBox="1"/>
          <p:nvPr/>
        </p:nvSpPr>
        <p:spPr>
          <a:xfrm>
            <a:off x="5770838" y="1273432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87596AE-83DB-04E6-B760-85AD1852B722}"/>
              </a:ext>
            </a:extLst>
          </p:cNvPr>
          <p:cNvSpPr txBox="1"/>
          <p:nvPr/>
        </p:nvSpPr>
        <p:spPr>
          <a:xfrm>
            <a:off x="5770838" y="5212529"/>
            <a:ext cx="635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F7FE700-3EE3-70AB-0BDF-BCE4011B046F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67304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995F0438-402A-95DE-DE6A-4181468A875E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545B4F8-B50E-4FA5-A33F-E77080CD23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99" y="537864"/>
            <a:ext cx="10394795" cy="6236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6753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6DC0C48-BD17-5901-829F-74EFFC6DA5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1359"/>
            <a:ext cx="12192000" cy="359528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CD13B12-26D9-503A-408B-2A1640711A26}"/>
              </a:ext>
            </a:extLst>
          </p:cNvPr>
          <p:cNvSpPr txBox="1"/>
          <p:nvPr/>
        </p:nvSpPr>
        <p:spPr>
          <a:xfrm>
            <a:off x="0" y="0"/>
            <a:ext cx="38471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zh-CN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9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6614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1029</Words>
  <Application>Microsoft Office PowerPoint</Application>
  <PresentationFormat>宽屏</PresentationFormat>
  <Paragraphs>93</Paragraphs>
  <Slides>18</Slides>
  <Notes>18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5" baseType="lpstr">
      <vt:lpstr>等线</vt:lpstr>
      <vt:lpstr>等线 Light</vt:lpstr>
      <vt:lpstr>Arial</vt:lpstr>
      <vt:lpstr>Calibri</vt:lpstr>
      <vt:lpstr>Times New Roman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黄 文涛</dc:creator>
  <cp:lastModifiedBy>黄 文涛</cp:lastModifiedBy>
  <cp:revision>21</cp:revision>
  <dcterms:created xsi:type="dcterms:W3CDTF">2023-01-07T13:30:29Z</dcterms:created>
  <dcterms:modified xsi:type="dcterms:W3CDTF">2023-02-13T03:29:06Z</dcterms:modified>
</cp:coreProperties>
</file>